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8" r:id="rId3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FF"/>
    <a:srgbClr val="97DB85"/>
    <a:srgbClr val="66FF99"/>
    <a:srgbClr val="FFE697"/>
    <a:srgbClr val="FFDD71"/>
    <a:srgbClr val="FFCA21"/>
    <a:srgbClr val="FFC71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824" autoAdjust="0"/>
    <p:restoredTop sz="94660"/>
  </p:normalViewPr>
  <p:slideViewPr>
    <p:cSldViewPr>
      <p:cViewPr varScale="1">
        <p:scale>
          <a:sx n="83" d="100"/>
          <a:sy n="83" d="100"/>
        </p:scale>
        <p:origin x="3672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59242594675664"/>
          <c:y val="0.1663823272090989"/>
          <c:w val="0.73193460192475945"/>
          <c:h val="0.73193460192475945"/>
        </c:manualLayout>
      </c:layout>
      <c:doughnut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PP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0.12500000000000008"/>
                  <c:y val="-7.407407407407408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11111111111111117"/>
                  <c:y val="0.10185185185185194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9.7222222222222265E-2"/>
                  <c:y val="8.796296296296320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0.12962962962962923"/>
                  <c:y val="5.092592592592595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0.12962962962962923"/>
                  <c:y val="9.2592592592592934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0.11111111111111117"/>
                  <c:y val="-1.388888888888892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0.1388888888888889"/>
                  <c:y val="-2.7777777777777849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-0.15277777777777776"/>
                  <c:y val="-5.092592592592595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0.11574074074074099"/>
                  <c:y val="-6.944444444444454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5.5555555555555476E-2"/>
                  <c:y val="-0.10648148148148168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-1.8518518518518549E-2"/>
                  <c:y val="-0.10648148148148168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 b="1">
                    <a:latin typeface="Arial" pitchFamily="34" charset="0"/>
                    <a:cs typeface="Arial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12</c:f>
              <c:strCache>
                <c:ptCount val="11"/>
                <c:pt idx="0">
                  <c:v>cellular processes</c:v>
                </c:pt>
                <c:pt idx="1">
                  <c:v>metabolic processes</c:v>
                </c:pt>
                <c:pt idx="2">
                  <c:v>response to stress</c:v>
                </c:pt>
                <c:pt idx="3">
                  <c:v>deveopmental processes</c:v>
                </c:pt>
                <c:pt idx="4">
                  <c:v>cell organization and biogenesis</c:v>
                </c:pt>
                <c:pt idx="5">
                  <c:v>transcription</c:v>
                </c:pt>
                <c:pt idx="6">
                  <c:v>protein metabolism</c:v>
                </c:pt>
                <c:pt idx="7">
                  <c:v>transport</c:v>
                </c:pt>
                <c:pt idx="8">
                  <c:v>signal transduction</c:v>
                </c:pt>
                <c:pt idx="9">
                  <c:v>electron transport/ energy pathways</c:v>
                </c:pt>
                <c:pt idx="10">
                  <c:v>others</c:v>
                </c:pt>
              </c:strCache>
            </c:strRef>
          </c:cat>
          <c:val>
            <c:numRef>
              <c:f>Sheet1!$B$2:$B$12</c:f>
              <c:numCache>
                <c:formatCode>General</c:formatCode>
                <c:ptCount val="11"/>
                <c:pt idx="0">
                  <c:v>20.941999999999986</c:v>
                </c:pt>
                <c:pt idx="1">
                  <c:v>17.800999999999988</c:v>
                </c:pt>
                <c:pt idx="2">
                  <c:v>36.126000000000012</c:v>
                </c:pt>
                <c:pt idx="3">
                  <c:v>0.52400000000000002</c:v>
                </c:pt>
                <c:pt idx="4">
                  <c:v>1.0469999999999982</c:v>
                </c:pt>
                <c:pt idx="5">
                  <c:v>4.7119999999999997</c:v>
                </c:pt>
                <c:pt idx="6">
                  <c:v>3.665</c:v>
                </c:pt>
                <c:pt idx="7">
                  <c:v>4.1879999999999926</c:v>
                </c:pt>
                <c:pt idx="8">
                  <c:v>2.6179999999999999</c:v>
                </c:pt>
                <c:pt idx="9">
                  <c:v>0.52400000000000002</c:v>
                </c:pt>
                <c:pt idx="10">
                  <c:v>7.85399999999999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54640897160605"/>
          <c:y val="0.14123541848935575"/>
          <c:w val="0.79359500516980863"/>
          <c:h val="0.72746208807232293"/>
        </c:manualLayout>
      </c:layout>
      <c:doughnutChart>
        <c:varyColors val="1"/>
        <c:ser>
          <c:idx val="0"/>
          <c:order val="0"/>
          <c:tx>
            <c:strRef>
              <c:f>Sheet1!$E$1</c:f>
              <c:strCache>
                <c:ptCount val="1"/>
                <c:pt idx="0">
                  <c:v>P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0.13636363636363635"/>
                  <c:y val="-8.796296296296310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7.5757575757575704E-2"/>
                  <c:y val="0.11574074074074089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0.15151515151515194"/>
                  <c:y val="6.481481481481493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0.13636363636363638"/>
                  <c:y val="3.240740740740746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0.12121212121212133"/>
                  <c:y val="-1.3888888888888919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0.13131313131313141"/>
                  <c:y val="-2.314814814814818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0.14141414141414177"/>
                  <c:y val="-4.166666666666666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-7.5757575757575774E-2"/>
                  <c:y val="-8.333333333333334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0.10101010101010099"/>
                  <c:y val="-0.10648148148148168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3.0303030303030311E-2"/>
                  <c:y val="-0.1111111111111111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2.0202020202020211E-2"/>
                  <c:y val="-0.1111111111111111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 b="1">
                    <a:latin typeface="Arial" pitchFamily="34" charset="0"/>
                    <a:cs typeface="Arial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12</c:f>
              <c:strCache>
                <c:ptCount val="11"/>
                <c:pt idx="0">
                  <c:v>cellular processes</c:v>
                </c:pt>
                <c:pt idx="1">
                  <c:v>metabolic processes</c:v>
                </c:pt>
                <c:pt idx="2">
                  <c:v>response to stress</c:v>
                </c:pt>
                <c:pt idx="3">
                  <c:v>deveopmental processes</c:v>
                </c:pt>
                <c:pt idx="4">
                  <c:v>cell organization and biogenesis</c:v>
                </c:pt>
                <c:pt idx="5">
                  <c:v>transcription</c:v>
                </c:pt>
                <c:pt idx="6">
                  <c:v>protein metabolism</c:v>
                </c:pt>
                <c:pt idx="7">
                  <c:v>transport</c:v>
                </c:pt>
                <c:pt idx="8">
                  <c:v>signal transduction</c:v>
                </c:pt>
                <c:pt idx="9">
                  <c:v>electron transport/ energy pathways</c:v>
                </c:pt>
                <c:pt idx="10">
                  <c:v>others</c:v>
                </c:pt>
              </c:strCache>
            </c:strRef>
          </c:cat>
          <c:val>
            <c:numRef>
              <c:f>Sheet1!$E$2:$E$12</c:f>
              <c:numCache>
                <c:formatCode>General</c:formatCode>
                <c:ptCount val="11"/>
                <c:pt idx="0">
                  <c:v>22.541</c:v>
                </c:pt>
                <c:pt idx="1">
                  <c:v>15.984</c:v>
                </c:pt>
                <c:pt idx="2">
                  <c:v>36.885000000000005</c:v>
                </c:pt>
                <c:pt idx="3">
                  <c:v>3.2789999999999999</c:v>
                </c:pt>
                <c:pt idx="4">
                  <c:v>0.41000000000000031</c:v>
                </c:pt>
                <c:pt idx="5">
                  <c:v>5.3279999999999914</c:v>
                </c:pt>
                <c:pt idx="6">
                  <c:v>2.4589999999999987</c:v>
                </c:pt>
                <c:pt idx="7">
                  <c:v>0</c:v>
                </c:pt>
                <c:pt idx="8">
                  <c:v>4.9180000000000001</c:v>
                </c:pt>
                <c:pt idx="9">
                  <c:v>0</c:v>
                </c:pt>
                <c:pt idx="10">
                  <c:v>8.197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81343548272731"/>
          <c:y val="6.6840551181102367E-2"/>
          <c:w val="0.69032879336028963"/>
          <c:h val="0.79819266732283478"/>
        </c:manualLayout>
      </c:layout>
      <c:doughnutChart>
        <c:varyColors val="1"/>
        <c:ser>
          <c:idx val="0"/>
          <c:order val="0"/>
          <c:tx>
            <c:strRef>
              <c:f>Sheet1!$D$1</c:f>
              <c:strCache>
                <c:ptCount val="1"/>
                <c:pt idx="0">
                  <c:v>D ALL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0.14912280701754385"/>
                  <c:y val="-4.411764705882373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8.3333333333333343E-2"/>
                  <c:y val="0.10294117647058838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8.7719298245614072E-2"/>
                  <c:y val="0.10784313725490199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0.11842105263157909"/>
                  <c:y val="5.392156862745085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0.11842105263157909"/>
                  <c:y val="4.9019607843137488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0.12719298245614041"/>
                  <c:y val="-2.451018990273270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0.12719298245614041"/>
                  <c:y val="-4.901960784313746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-0.12280701754385964"/>
                  <c:y val="-9.803921568627456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0.10964912280701759"/>
                  <c:y val="-0.14215686274509806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5.2631578947368474E-2"/>
                  <c:y val="-0.1323529411764708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-1.7543859649122858E-2"/>
                  <c:y val="-0.1323529411764708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 b="1">
                    <a:latin typeface="Arial" pitchFamily="34" charset="0"/>
                    <a:cs typeface="Arial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12</c:f>
              <c:strCache>
                <c:ptCount val="11"/>
                <c:pt idx="0">
                  <c:v>cellular processes</c:v>
                </c:pt>
                <c:pt idx="1">
                  <c:v>metabolic processes</c:v>
                </c:pt>
                <c:pt idx="2">
                  <c:v>response to stress</c:v>
                </c:pt>
                <c:pt idx="3">
                  <c:v>deveopmental processes</c:v>
                </c:pt>
                <c:pt idx="4">
                  <c:v>cell organization and biogenesis</c:v>
                </c:pt>
                <c:pt idx="5">
                  <c:v>transcription</c:v>
                </c:pt>
                <c:pt idx="6">
                  <c:v>protein metabolism</c:v>
                </c:pt>
                <c:pt idx="7">
                  <c:v>transport</c:v>
                </c:pt>
                <c:pt idx="8">
                  <c:v>signal transduction</c:v>
                </c:pt>
                <c:pt idx="9">
                  <c:v>electron transport/ energy pathways</c:v>
                </c:pt>
                <c:pt idx="10">
                  <c:v>others</c:v>
                </c:pt>
              </c:strCache>
            </c:strRef>
          </c:cat>
          <c:val>
            <c:numRef>
              <c:f>Sheet1!$D$2:$D$12</c:f>
              <c:numCache>
                <c:formatCode>General</c:formatCode>
                <c:ptCount val="11"/>
                <c:pt idx="0">
                  <c:v>21.384</c:v>
                </c:pt>
                <c:pt idx="1">
                  <c:v>15.094000000000001</c:v>
                </c:pt>
                <c:pt idx="2">
                  <c:v>27.673000000000005</c:v>
                </c:pt>
                <c:pt idx="3">
                  <c:v>8.1760000000000002</c:v>
                </c:pt>
                <c:pt idx="4">
                  <c:v>2.5159999999999987</c:v>
                </c:pt>
                <c:pt idx="5">
                  <c:v>6.2889999999999997</c:v>
                </c:pt>
                <c:pt idx="6">
                  <c:v>3.774</c:v>
                </c:pt>
                <c:pt idx="7">
                  <c:v>1.258</c:v>
                </c:pt>
                <c:pt idx="8">
                  <c:v>5.0309999999999997</c:v>
                </c:pt>
                <c:pt idx="9">
                  <c:v>1.887</c:v>
                </c:pt>
                <c:pt idx="10">
                  <c:v>6.9180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91666666666671"/>
          <c:y val="0.16913604549431324"/>
          <c:w val="0.63888877952755962"/>
          <c:h val="0.70987642169728793"/>
        </c:manualLayout>
      </c:layout>
      <c:doughnutChart>
        <c:varyColors val="1"/>
        <c:ser>
          <c:idx val="0"/>
          <c:order val="0"/>
          <c:tx>
            <c:strRef>
              <c:f>Sheet1!$F$1</c:f>
              <c:strCache>
                <c:ptCount val="1"/>
                <c:pt idx="0">
                  <c:v>DP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6.666666666666668E-2"/>
                  <c:y val="-8.333333333333334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12916666666666668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8.7500000000000008E-2"/>
                  <c:y val="7.40740740740740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0.12083333333333333"/>
                  <c:y val="-9.25925925925929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0.1"/>
                  <c:y val="-9.25925925925929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0.1"/>
                  <c:y val="-4.166666666666662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0.10833333333333332"/>
                  <c:y val="-6.481481481481493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-0.12083333333333333"/>
                  <c:y val="-8.333333333333334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4.1666666666666664E-2"/>
                  <c:y val="-8.796296296296313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2.5000000000000001E-2"/>
                  <c:y val="-0.1342592592592592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 b="1">
                    <a:latin typeface="Arial" pitchFamily="34" charset="0"/>
                    <a:cs typeface="Arial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1!$A$2:$A$12</c:f>
              <c:strCache>
                <c:ptCount val="11"/>
                <c:pt idx="0">
                  <c:v>cellular processes</c:v>
                </c:pt>
                <c:pt idx="1">
                  <c:v>metabolic processes</c:v>
                </c:pt>
                <c:pt idx="2">
                  <c:v>response to stress</c:v>
                </c:pt>
                <c:pt idx="3">
                  <c:v>deveopmental processes</c:v>
                </c:pt>
                <c:pt idx="4">
                  <c:v>cell organization and biogenesis</c:v>
                </c:pt>
                <c:pt idx="5">
                  <c:v>transcription</c:v>
                </c:pt>
                <c:pt idx="6">
                  <c:v>protein metabolism</c:v>
                </c:pt>
                <c:pt idx="7">
                  <c:v>transport</c:v>
                </c:pt>
                <c:pt idx="8">
                  <c:v>signal transduction</c:v>
                </c:pt>
                <c:pt idx="9">
                  <c:v>electron transport/ energy pathways</c:v>
                </c:pt>
                <c:pt idx="10">
                  <c:v>others</c:v>
                </c:pt>
              </c:strCache>
            </c:strRef>
          </c:cat>
          <c:val>
            <c:numRef>
              <c:f>Sheet1!$F$2:$F$12</c:f>
              <c:numCache>
                <c:formatCode>General</c:formatCode>
                <c:ptCount val="11"/>
                <c:pt idx="0">
                  <c:v>17.5</c:v>
                </c:pt>
                <c:pt idx="1">
                  <c:v>18.75</c:v>
                </c:pt>
                <c:pt idx="2">
                  <c:v>40</c:v>
                </c:pt>
                <c:pt idx="3">
                  <c:v>5</c:v>
                </c:pt>
                <c:pt idx="4">
                  <c:v>2.5</c:v>
                </c:pt>
                <c:pt idx="5">
                  <c:v>0</c:v>
                </c:pt>
                <c:pt idx="6">
                  <c:v>1.25</c:v>
                </c:pt>
                <c:pt idx="7">
                  <c:v>3.125</c:v>
                </c:pt>
                <c:pt idx="8">
                  <c:v>0.625000000000001</c:v>
                </c:pt>
                <c:pt idx="9">
                  <c:v>0.625000000000001</c:v>
                </c:pt>
                <c:pt idx="10">
                  <c:v>10.6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81481481481484"/>
          <c:y val="0.11481481481481463"/>
          <c:w val="0.75185185185185277"/>
          <c:h val="0.75185185185185277"/>
        </c:manualLayout>
      </c:layout>
      <c:doughnutChart>
        <c:varyColors val="1"/>
        <c:ser>
          <c:idx val="0"/>
          <c:order val="0"/>
          <c:tx>
            <c:strRef>
              <c:f>Sheet1!$C$1</c:f>
              <c:strCache>
                <c:ptCount val="1"/>
                <c:pt idx="0">
                  <c:v>PD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0.12499999999999992"/>
                  <c:y val="-7.870370370370373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12962962962962923"/>
                  <c:y val="6.944444444444450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0.12500000000000006"/>
                  <c:y val="0.125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6.0185185185185147E-2"/>
                  <c:y val="0.11574074074074089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0.11574074074074087"/>
                  <c:y val="6.944444444444450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0.12962962962962929"/>
                  <c:y val="4.166666666666666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0.12962962962962923"/>
                  <c:y val="2.777777777777786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-0.12962962962962923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0.12962962962962923"/>
                  <c:y val="-1.851851851851854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0.125"/>
                  <c:y val="-6.481481481481493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-0.11574074074074089"/>
                  <c:y val="-0.10648148148148168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 b="1">
                    <a:latin typeface="Arial" pitchFamily="34" charset="0"/>
                    <a:cs typeface="Arial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12</c:f>
              <c:strCache>
                <c:ptCount val="11"/>
                <c:pt idx="0">
                  <c:v>cellular processes</c:v>
                </c:pt>
                <c:pt idx="1">
                  <c:v>metabolic processes</c:v>
                </c:pt>
                <c:pt idx="2">
                  <c:v>response to stress</c:v>
                </c:pt>
                <c:pt idx="3">
                  <c:v>deveopmental processes</c:v>
                </c:pt>
                <c:pt idx="4">
                  <c:v>cell organization and biogenesis</c:v>
                </c:pt>
                <c:pt idx="5">
                  <c:v>transcription</c:v>
                </c:pt>
                <c:pt idx="6">
                  <c:v>protein metabolism</c:v>
                </c:pt>
                <c:pt idx="7">
                  <c:v>transport</c:v>
                </c:pt>
                <c:pt idx="8">
                  <c:v>signal transduction</c:v>
                </c:pt>
                <c:pt idx="9">
                  <c:v>electron transport/ energy pathways</c:v>
                </c:pt>
                <c:pt idx="10">
                  <c:v>others</c:v>
                </c:pt>
              </c:strCache>
            </c:strRef>
          </c:cat>
          <c:val>
            <c:numRef>
              <c:f>Sheet1!$C$2:$C$12</c:f>
              <c:numCache>
                <c:formatCode>General</c:formatCode>
                <c:ptCount val="11"/>
                <c:pt idx="0">
                  <c:v>20.395</c:v>
                </c:pt>
                <c:pt idx="1">
                  <c:v>20.395</c:v>
                </c:pt>
                <c:pt idx="2">
                  <c:v>20.395000000000003</c:v>
                </c:pt>
                <c:pt idx="3">
                  <c:v>4.6049999999999933</c:v>
                </c:pt>
                <c:pt idx="4">
                  <c:v>0.65800000000000114</c:v>
                </c:pt>
                <c:pt idx="5">
                  <c:v>2.6319999999999997</c:v>
                </c:pt>
                <c:pt idx="6">
                  <c:v>5.2629999999999955</c:v>
                </c:pt>
                <c:pt idx="7">
                  <c:v>6.5789999999999997</c:v>
                </c:pt>
                <c:pt idx="8">
                  <c:v>3.2890000000000001</c:v>
                </c:pt>
                <c:pt idx="9">
                  <c:v>1.3160000000000001</c:v>
                </c:pt>
                <c:pt idx="10">
                  <c:v>14.4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84608A-92AC-4A8D-AD4B-45708AD1324E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0AD5E9-2A9A-4159-8E18-0237F23CC1E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3B8CDA-6B41-48CD-8523-9CBD8848E0DF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6820AA-6504-4998-A90D-B90DE2707F3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934AE7-2B01-4269-B0E8-DE2FE5712DF6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C4A5A5-03E4-4634-83A9-0520FCF49B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1FE1A6-8854-41F3-9945-296099D48665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CE0617-8872-4D71-8F4F-34C72DA7A2C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CBAFB5-9F71-4155-94B9-DC67FDB4AB0C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B5D65F-F824-464F-808B-FDDA5350147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EC787F-4D0A-475C-9314-4B3E30B67B41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EC9E2F-F5DE-4603-A384-A5A5CEC1DD0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E99B7E-5457-4CFA-870F-EB132C5CC500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5AD77F-94FB-4038-833D-151E117F36E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3E27D9-E32A-4EE4-924E-A3F8756E0AA7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CB0A7D-5CBC-4DF0-8AF6-EC88035F86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2441DA-6F70-4018-8398-26C2E0662FAD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7DA457-0D8C-4247-9AF4-FD8175AE1E2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155604-B54B-44C5-933E-D1E7601E05AA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EF3CB7-0E47-416D-BCE4-A4F7D0896ED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BCA3B3-D194-49BE-9D93-EBDCCBB919E3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F003CF-4B10-43FE-82BE-30E97E2557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341A4B9-500B-4653-A40B-A9B18936E2EF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62E1ECF-1A2E-471D-A33A-B53D46382B5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1.em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/>
          <p:nvPr/>
        </p:nvGraphicFramePr>
        <p:xfrm>
          <a:off x="381000" y="5410200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/>
          <p:nvPr/>
        </p:nvGraphicFramePr>
        <p:xfrm>
          <a:off x="381000" y="2686050"/>
          <a:ext cx="2514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381000" y="533400"/>
          <a:ext cx="274320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101" name="TextBox 28"/>
          <p:cNvSpPr txBox="1">
            <a:spLocks noChangeArrowheads="1"/>
          </p:cNvSpPr>
          <p:nvPr/>
        </p:nvSpPr>
        <p:spPr bwMode="auto">
          <a:xfrm>
            <a:off x="228600" y="577850"/>
            <a:ext cx="2921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>
                <a:latin typeface="Calibri" pitchFamily="34" charset="0"/>
              </a:rPr>
              <a:t>A)</a:t>
            </a:r>
          </a:p>
        </p:txBody>
      </p:sp>
      <p:sp>
        <p:nvSpPr>
          <p:cNvPr id="4102" name="TextBox 29"/>
          <p:cNvSpPr txBox="1">
            <a:spLocks noChangeArrowheads="1"/>
          </p:cNvSpPr>
          <p:nvPr/>
        </p:nvSpPr>
        <p:spPr bwMode="auto">
          <a:xfrm>
            <a:off x="160338" y="3057525"/>
            <a:ext cx="2921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>
                <a:latin typeface="Calibri" pitchFamily="34" charset="0"/>
              </a:rPr>
              <a:t>B)</a:t>
            </a:r>
          </a:p>
        </p:txBody>
      </p:sp>
      <p:sp>
        <p:nvSpPr>
          <p:cNvPr id="4103" name="TextBox 29"/>
          <p:cNvSpPr txBox="1">
            <a:spLocks noChangeArrowheads="1"/>
          </p:cNvSpPr>
          <p:nvPr/>
        </p:nvSpPr>
        <p:spPr bwMode="auto">
          <a:xfrm>
            <a:off x="242888" y="5575300"/>
            <a:ext cx="2921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>
                <a:latin typeface="Calibri" pitchFamily="34" charset="0"/>
              </a:rPr>
              <a:t>C)</a:t>
            </a:r>
          </a:p>
        </p:txBody>
      </p:sp>
      <p:graphicFrame>
        <p:nvGraphicFramePr>
          <p:cNvPr id="9" name="Chart 8"/>
          <p:cNvGraphicFramePr/>
          <p:nvPr/>
        </p:nvGraphicFramePr>
        <p:xfrm>
          <a:off x="3581400" y="152400"/>
          <a:ext cx="3048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Chart 9"/>
          <p:cNvGraphicFramePr/>
          <p:nvPr/>
        </p:nvGraphicFramePr>
        <p:xfrm>
          <a:off x="3886200" y="2667000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106" name="TextBox 96"/>
          <p:cNvSpPr txBox="1">
            <a:spLocks noChangeArrowheads="1"/>
          </p:cNvSpPr>
          <p:nvPr/>
        </p:nvSpPr>
        <p:spPr bwMode="auto">
          <a:xfrm>
            <a:off x="2670175" y="107950"/>
            <a:ext cx="155575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800" b="1">
                <a:latin typeface="Calibri" pitchFamily="34" charset="0"/>
              </a:rPr>
              <a:t>Supplementary figure. 4</a:t>
            </a:r>
          </a:p>
        </p:txBody>
      </p:sp>
      <p:sp>
        <p:nvSpPr>
          <p:cNvPr id="4107" name="TextBox 28"/>
          <p:cNvSpPr txBox="1">
            <a:spLocks noChangeArrowheads="1"/>
          </p:cNvSpPr>
          <p:nvPr/>
        </p:nvSpPr>
        <p:spPr bwMode="auto">
          <a:xfrm>
            <a:off x="3556000" y="495300"/>
            <a:ext cx="280988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>
                <a:latin typeface="Calibri" pitchFamily="34" charset="0"/>
              </a:rPr>
              <a:t>D)</a:t>
            </a:r>
          </a:p>
        </p:txBody>
      </p:sp>
      <p:sp>
        <p:nvSpPr>
          <p:cNvPr id="4108" name="TextBox 28"/>
          <p:cNvSpPr txBox="1">
            <a:spLocks noChangeArrowheads="1"/>
          </p:cNvSpPr>
          <p:nvPr/>
        </p:nvSpPr>
        <p:spPr bwMode="auto">
          <a:xfrm>
            <a:off x="3605213" y="2984500"/>
            <a:ext cx="2667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>
                <a:latin typeface="Calibri" pitchFamily="34" charset="0"/>
              </a:rPr>
              <a:t>E)</a:t>
            </a:r>
          </a:p>
        </p:txBody>
      </p:sp>
      <p:pic>
        <p:nvPicPr>
          <p:cNvPr id="4109" name="Picture 1"/>
          <p:cNvPicPr>
            <a:picLocks noChangeAspect="1"/>
          </p:cNvPicPr>
          <p:nvPr/>
        </p:nvPicPr>
        <p:blipFill>
          <a:blip r:embed="rId7"/>
          <a:srcRect l="36546" t="3406" r="4533" b="5556"/>
          <a:stretch>
            <a:fillRect/>
          </a:stretch>
        </p:blipFill>
        <p:spPr bwMode="auto">
          <a:xfrm>
            <a:off x="3262313" y="5480050"/>
            <a:ext cx="3292475" cy="3527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Rectangle 4"/>
          <p:cNvSpPr>
            <a:spLocks noChangeArrowheads="1"/>
          </p:cNvSpPr>
          <p:nvPr/>
        </p:nvSpPr>
        <p:spPr bwMode="auto">
          <a:xfrm>
            <a:off x="0" y="3001963"/>
            <a:ext cx="6858000" cy="831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/>
              <a:t>Supplementary figure S4.</a:t>
            </a:r>
            <a:r>
              <a:rPr lang="en-US" sz="1200"/>
              <a:t> </a:t>
            </a:r>
            <a:r>
              <a:rPr lang="en-US" sz="1200" b="1"/>
              <a:t>Functional categorization of top 25 transcripts expressed in individual and combined stressed leaves. </a:t>
            </a:r>
            <a:r>
              <a:rPr lang="en-US" sz="1200"/>
              <a:t>Gene ontology (GO) biological processes (TAIR) for top 25 genes (Supplementary Figure 3) expressed under D </a:t>
            </a:r>
            <a:r>
              <a:rPr lang="en-US" sz="1200" b="1"/>
              <a:t>(A)</a:t>
            </a:r>
            <a:r>
              <a:rPr lang="en-US" sz="1200"/>
              <a:t> P </a:t>
            </a:r>
            <a:r>
              <a:rPr lang="en-US" sz="1200" b="1"/>
              <a:t>(B) </a:t>
            </a:r>
            <a:r>
              <a:rPr lang="en-US" sz="1200"/>
              <a:t>PP </a:t>
            </a:r>
            <a:r>
              <a:rPr lang="en-US" sz="1200" b="1"/>
              <a:t>(C) </a:t>
            </a:r>
            <a:r>
              <a:rPr lang="en-US" sz="1200"/>
              <a:t>DP </a:t>
            </a:r>
            <a:r>
              <a:rPr lang="en-US" sz="1200" b="1"/>
              <a:t>(D) </a:t>
            </a:r>
            <a:r>
              <a:rPr lang="en-US" sz="1200"/>
              <a:t>and</a:t>
            </a:r>
            <a:r>
              <a:rPr lang="en-US" sz="1200" b="1"/>
              <a:t> </a:t>
            </a:r>
            <a:r>
              <a:rPr lang="en-US" sz="1200"/>
              <a:t>PD stress treatments </a:t>
            </a:r>
            <a:r>
              <a:rPr lang="en-US" sz="1200" b="1"/>
              <a:t>(E) </a:t>
            </a:r>
            <a:r>
              <a:rPr lang="en-US" sz="1200"/>
              <a:t>are shown here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28C09C9D97D24780058C99077D8847" ma:contentTypeVersion="7" ma:contentTypeDescription="Create a new document." ma:contentTypeScope="" ma:versionID="0132886fdf3e2c25019eb3cd8923805d">
  <xsd:schema xmlns:xsd="http://www.w3.org/2001/XMLSchema" xmlns:p="http://schemas.microsoft.com/office/2006/metadata/properties" xmlns:ns2="39616538-2d66-4de6-9e6e-2b8794b75252" targetNamespace="http://schemas.microsoft.com/office/2006/metadata/properties" ma:root="true" ma:fieldsID="afb14a4498c4490eaa362745f3dd1134" ns2:_="">
    <xsd:import namespace="39616538-2d66-4de6-9e6e-2b8794b7525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616538-2d66-4de6-9e6e-2b8794b7525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616538-2d66-4de6-9e6e-2b8794b75252">Presentation</DocumentType>
    <TitleName xmlns="39616538-2d66-4de6-9e6e-2b8794b75252">Presentation 4.PPTX</TitleName>
    <Checked_x0020_Out_x0020_To xmlns="39616538-2d66-4de6-9e6e-2b8794b75252">
      <UserInfo>
        <DisplayName/>
        <AccountId xsi:nil="true"/>
        <AccountType/>
      </UserInfo>
    </Checked_x0020_Out_x0020_To>
    <FileFormat xmlns="39616538-2d66-4de6-9e6e-2b8794b75252">PPTX</FileFormat>
    <DocumentId xmlns="39616538-2d66-4de6-9e6e-2b8794b75252">Presentation 4.PPTX</DocumentId>
    <StageName xmlns="39616538-2d66-4de6-9e6e-2b8794b75252" xsi:nil="true"/>
    <IsDeleted xmlns="39616538-2d66-4de6-9e6e-2b8794b75252">false</IsDeleted>
  </documentManagement>
</p:properties>
</file>

<file path=customXml/itemProps1.xml><?xml version="1.0" encoding="utf-8"?>
<ds:datastoreItem xmlns:ds="http://schemas.openxmlformats.org/officeDocument/2006/customXml" ds:itemID="{8F4AEA32-BFBB-4C51-9761-30535DD2B0CF}"/>
</file>

<file path=customXml/itemProps2.xml><?xml version="1.0" encoding="utf-8"?>
<ds:datastoreItem xmlns:ds="http://schemas.openxmlformats.org/officeDocument/2006/customXml" ds:itemID="{C3B9057D-5E52-4417-81BF-14937C2CC988}"/>
</file>

<file path=customXml/itemProps3.xml><?xml version="1.0" encoding="utf-8"?>
<ds:datastoreItem xmlns:ds="http://schemas.openxmlformats.org/officeDocument/2006/customXml" ds:itemID="{F2D5D69B-F5F3-4446-8ED2-472C8C5D0352}"/>
</file>

<file path=docProps/app.xml><?xml version="1.0" encoding="utf-8"?>
<Properties xmlns="http://schemas.openxmlformats.org/officeDocument/2006/extended-properties" xmlns:vt="http://schemas.openxmlformats.org/officeDocument/2006/docPropsVTypes">
  <TotalTime>2518</TotalTime>
  <Words>134</Words>
  <Application>Microsoft Office PowerPoint</Application>
  <PresentationFormat>On-screen Show (4:3)</PresentationFormat>
  <Paragraphs>6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ll</dc:creator>
  <cp:lastModifiedBy>Senthil K Muthappa</cp:lastModifiedBy>
  <cp:revision>15</cp:revision>
  <dcterms:created xsi:type="dcterms:W3CDTF">2016-03-16T13:56:20Z</dcterms:created>
  <dcterms:modified xsi:type="dcterms:W3CDTF">2016-04-03T07:37:24Z</dcterms:modified>
</cp:coreProperties>
</file>